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AE8D68-DA0E-4BD1-AD0A-E2CE3D65D4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34776A-F5E7-4346-BDE2-7520DD4F6C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F8FF96-F4C4-43F8-A7A0-94527672A6A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78BDE1-5F97-43B4-A36D-C2EB96536D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7F0DC-027D-484F-BCFD-CC394B783E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023DB4-4C8D-49C7-80B9-79637BB144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0B68EA-2E85-48A5-98A7-077881AB0F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CDA2DA-7AF4-456B-A62A-3834DB9F8F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1B3FC5-B86A-44DF-9E5B-7252041128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9ACB6-9B90-445F-80A8-A72A5E8CB3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E31DDC-A14F-41AC-BD8B-9CB4538502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8F4CD1-981B-4E6F-BE7D-10E0265874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EA9FAC-BA8E-49F8-95F2-75D4FEDA903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05280" y="228600"/>
            <a:ext cx="255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500280" y="1447920"/>
            <a:ext cx="1895400" cy="6426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Drug sensitiv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phenotyp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182600" y="4997520"/>
            <a:ext cx="1197360" cy="6426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SNP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genotyp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275880" y="5029200"/>
            <a:ext cx="1386360" cy="6426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mR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expr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684960" y="3505320"/>
            <a:ext cx="1386360" cy="64260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miR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express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H="1">
            <a:off x="1752120" y="2286000"/>
            <a:ext cx="1676520" cy="25146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410080" y="2286000"/>
            <a:ext cx="1600200" cy="259092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flipH="1">
            <a:off x="2666880" y="5410080"/>
            <a:ext cx="327672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flipH="1">
            <a:off x="2437920" y="4114800"/>
            <a:ext cx="1143000" cy="9144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257800" y="4191120"/>
            <a:ext cx="914400" cy="83808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419720" y="2209680"/>
            <a:ext cx="0" cy="11430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732280" y="3276720"/>
            <a:ext cx="2075040" cy="550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Step 1. Gene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correlated with drug phenoty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(P&lt;0.05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369960" y="2514600"/>
            <a:ext cx="2075040" cy="550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Step 2. miRNA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correlated with drug phenoty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(P&lt;0.05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719240" y="4343400"/>
            <a:ext cx="1828080" cy="550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Step 3. Inverse correl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between miRNA and mR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(P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Arial"/>
                <a:ea typeface="宋体"/>
              </a:rPr>
              <a:t>&lt;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.000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283200" y="5486400"/>
            <a:ext cx="2161800" cy="550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Step 4. SNPs cis/trans-regulate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gene expres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(P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Arial"/>
                <a:ea typeface="宋体"/>
              </a:rPr>
              <a:t>&lt;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.000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215800" y="4343400"/>
            <a:ext cx="1683360" cy="550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Step 5. SNPs associate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with miR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(P&lt;0.05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453680" y="3200400"/>
            <a:ext cx="1683360" cy="5508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Step 6. SNPs associated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with drug phenotyp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(P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Arial"/>
                <a:ea typeface="宋体"/>
              </a:rPr>
              <a:t>&lt;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.0001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CBIS</cp:lastModifiedBy>
  <dcterms:modified xsi:type="dcterms:W3CDTF">2013-08-06T16:14:15Z</dcterms:modified>
  <cp:revision>24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